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42E800F6-BDC7-432A-A350-15217B940675}"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342720" y="21333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A636A99F-35A7-449B-AB72-70FA785432E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980B3AD8-0768-45D0-9B89-179637669018}"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34272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242964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4516560" y="21333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34272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242964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4516560" y="5285160"/>
            <a:ext cx="1987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7C50F375-9CD8-4256-B35E-B7114C5ECBF0}"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2720" y="2133360"/>
            <a:ext cx="6172200" cy="603396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3D90CFE-B346-4FE9-AC2F-6EB2BCEADFE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342720" y="2133360"/>
            <a:ext cx="617220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C670D1A-F5E7-4DEB-A2BF-49CE866C884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DCB145E-08D6-4ED5-946A-5F10962FC9D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358F5B20-2AB4-4D37-8407-63C8D6EA020C}"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66480"/>
            <a:ext cx="6172200" cy="706500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B84271E-1355-49EA-B8BF-94613DE1E7E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35053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3427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06B8B90-B552-431F-A2E0-D72A7CE109E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342720" y="2133360"/>
            <a:ext cx="3011760" cy="6033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3505320" y="52851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6359C44-24D2-439E-A557-9466ED9AA8A3}"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3427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3505320" y="2133360"/>
            <a:ext cx="301176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342720" y="5285160"/>
            <a:ext cx="6172200" cy="28778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0FD17E5-9A5C-464B-929D-3C383D652935}"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66480"/>
            <a:ext cx="6172200" cy="152388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2720" y="2133360"/>
            <a:ext cx="6172200" cy="603396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2720" y="8475480"/>
            <a:ext cx="1600200" cy="4856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ja-JP"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2343240" y="8475480"/>
            <a:ext cx="2171520" cy="4856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4914720" y="8475480"/>
            <a:ext cx="1600200" cy="4856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ja-JP"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58BEB76-DFA2-4F50-8898-BC2AFF191604}" type="slidenum">
              <a:rPr b="0" lang="ja-JP"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41" name="Picture 3" descr=""/>
          <p:cNvPicPr/>
          <p:nvPr/>
        </p:nvPicPr>
        <p:blipFill>
          <a:blip r:embed="rId1"/>
          <a:stretch/>
        </p:blipFill>
        <p:spPr>
          <a:xfrm>
            <a:off x="1989000" y="1619280"/>
            <a:ext cx="2048040" cy="1865160"/>
          </a:xfrm>
          <a:prstGeom prst="rect">
            <a:avLst/>
          </a:prstGeom>
          <a:ln w="0">
            <a:noFill/>
          </a:ln>
        </p:spPr>
      </p:pic>
      <p:sp>
        <p:nvSpPr>
          <p:cNvPr id="42" name="テキスト ボックス 5"/>
          <p:cNvSpPr/>
          <p:nvPr/>
        </p:nvSpPr>
        <p:spPr>
          <a:xfrm>
            <a:off x="549360" y="611280"/>
            <a:ext cx="5832360" cy="93096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ea typeface="Arial"/>
              </a:rPr>
              <a:t>Supporting information Fig. S1. </a:t>
            </a:r>
            <a:r>
              <a:rPr b="0" lang="en-US" sz="1100" spc="-1" strike="noStrike">
                <a:solidFill>
                  <a:srgbClr val="000000"/>
                </a:solidFill>
                <a:latin typeface="Arial"/>
                <a:ea typeface="Arial"/>
              </a:rPr>
              <a:t>SDS-PAGE of recombinant LcBADH1 and LcBADH2.  LcBADH1 and LcBADH2 were expressed as fusion proteins in Escherichia coli and purified as described in Materials and methods.  After enterokinase treatment, 10 μg protein was electrophoresed.  SDS-PAGE samples were stained using Coomassie brilliant blue R-250 and the size of molecular mass standards are shown on the left in kDa.</a:t>
            </a:r>
            <a:endParaRPr b="0" lang="en-US" sz="11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3-07-31T11:16:51Z</dcterms:created>
  <dc:creator>mitchy</dc:creator>
  <dc:description/>
  <dc:language>en-US</dc:language>
  <cp:lastModifiedBy>mitchy</cp:lastModifiedBy>
  <dcterms:modified xsi:type="dcterms:W3CDTF">2013-07-31T11:20:35Z</dcterms:modified>
  <cp:revision>1</cp:revision>
  <dc:subject/>
  <dc:title>スライド 1</dc:title>
</cp:coreProperties>
</file>